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58" r:id="rId5"/>
    <p:sldId id="259" r:id="rId6"/>
    <p:sldId id="260" r:id="rId7"/>
    <p:sldId id="261" r:id="rId8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48">
          <p15:clr>
            <a:srgbClr val="A4A3A4"/>
          </p15:clr>
        </p15:guide>
        <p15:guide id="3" pos="383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0" d="100"/>
          <a:sy n="110" d="100"/>
        </p:scale>
        <p:origin x="-1644" y="-78"/>
      </p:cViewPr>
      <p:guideLst>
        <p:guide orient="horz" pos="2160"/>
        <p:guide pos="348"/>
        <p:guide pos="38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real%20time%20pcr\2024.10.24-A427-CRABP2,%20FNDC4-shGRP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real%20time%20pcr\2024.10.24-A427-CRABP2,%20FNDC4-shGRP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2024&#45380;\2024.07.27-siCRABP2,FNDC4-invasion,%20proliferation-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2024&#45380;\2024.07.27-siCRABP2,FNDC4-invasion,%20proliferation-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2024&#45380;\2024.07.27-siCRABP2,FNDC4-invasion,%20proliferation-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2;&#53944;\2024&#45380;\2024.07.27-siCRABP2,FNDC4-invasion,%20proliferation-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436;&#47928;%20GRPR%20figure\Submission\1_Cells%20(IF_5.1)\revision\data\metastasis%20burde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icradp2!$L$17</c:f>
              <c:strCache>
                <c:ptCount val="1"/>
                <c:pt idx="0">
                  <c:v>CRADP2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28A-4BE0-B9D7-76FFBE61EFD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28A-4BE0-B9D7-76FFBE61EFD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28A-4BE0-B9D7-76FFBE61EFDC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B28A-4BE0-B9D7-76FFBE61EFDC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sicradp2!$M$18:$M$21</c:f>
                <c:numCache>
                  <c:formatCode>General</c:formatCode>
                  <c:ptCount val="4"/>
                  <c:pt idx="0">
                    <c:v>1.1593140404611532E-2</c:v>
                  </c:pt>
                  <c:pt idx="1">
                    <c:v>3.20582330783625E-3</c:v>
                  </c:pt>
                  <c:pt idx="2">
                    <c:v>1.234917954727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cat>
            <c:strRef>
              <c:f>sicradp2!$K$18:$K$20</c:f>
              <c:strCache>
                <c:ptCount val="3"/>
                <c:pt idx="0">
                  <c:v>shControl</c:v>
                </c:pt>
                <c:pt idx="1">
                  <c:v>shGRPR-1</c:v>
                </c:pt>
                <c:pt idx="2">
                  <c:v>shGRPR-2</c:v>
                </c:pt>
              </c:strCache>
            </c:strRef>
          </c:cat>
          <c:val>
            <c:numRef>
              <c:f>sicradp2!$L$18:$L$20</c:f>
              <c:numCache>
                <c:formatCode>0.00</c:formatCode>
                <c:ptCount val="3"/>
                <c:pt idx="0">
                  <c:v>0.99782584489797099</c:v>
                </c:pt>
                <c:pt idx="1">
                  <c:v>0.80108270685555549</c:v>
                </c:pt>
                <c:pt idx="2">
                  <c:v>0.683242820981567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28A-4BE0-B9D7-76FFBE61EFDC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204550144"/>
        <c:axId val="184188224"/>
      </c:barChart>
      <c:catAx>
        <c:axId val="204550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84188224"/>
        <c:crosses val="autoZero"/>
        <c:auto val="1"/>
        <c:lblAlgn val="ctr"/>
        <c:lblOffset val="100"/>
        <c:noMultiLvlLbl val="0"/>
      </c:catAx>
      <c:valAx>
        <c:axId val="184188224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ko-KR"/>
          </a:p>
        </c:txPr>
        <c:crossAx val="20455014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ifndc4!$L$17</c:f>
              <c:strCache>
                <c:ptCount val="1"/>
                <c:pt idx="0">
                  <c:v>FNDC4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513-4BF3-8143-4F2F07BAE27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513-4BF3-8143-4F2F07BAE27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513-4BF3-8143-4F2F07BAE273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5875">
                <a:solidFill>
                  <a:sysClr val="windowText" lastClr="000000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4513-4BF3-8143-4F2F07BAE273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sifndc4!$M$18:$M$21</c:f>
                <c:numCache>
                  <c:formatCode>General</c:formatCode>
                  <c:ptCount val="4"/>
                  <c:pt idx="0">
                    <c:v>2.9224187895925187E-2</c:v>
                  </c:pt>
                  <c:pt idx="1">
                    <c:v>1.2196404980794886E-2</c:v>
                  </c:pt>
                  <c:pt idx="2">
                    <c:v>4.124694815033217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cat>
            <c:strRef>
              <c:f>sifndc4!$K$18:$K$20</c:f>
              <c:strCache>
                <c:ptCount val="3"/>
                <c:pt idx="0">
                  <c:v>shControl</c:v>
                </c:pt>
                <c:pt idx="1">
                  <c:v>shGRPR-1</c:v>
                </c:pt>
                <c:pt idx="2">
                  <c:v>shGRPR-2</c:v>
                </c:pt>
              </c:strCache>
            </c:strRef>
          </c:cat>
          <c:val>
            <c:numRef>
              <c:f>sifndc4!$L$18:$L$20</c:f>
              <c:numCache>
                <c:formatCode>0.00</c:formatCode>
                <c:ptCount val="3"/>
                <c:pt idx="0">
                  <c:v>1.0031785110913038</c:v>
                </c:pt>
                <c:pt idx="1">
                  <c:v>0.65390935376224679</c:v>
                </c:pt>
                <c:pt idx="2">
                  <c:v>0.673641988458047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4513-4BF3-8143-4F2F07BAE273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203930624"/>
        <c:axId val="210551936"/>
      </c:barChart>
      <c:catAx>
        <c:axId val="20393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10551936"/>
        <c:crosses val="autoZero"/>
        <c:auto val="1"/>
        <c:lblAlgn val="ctr"/>
        <c:lblOffset val="100"/>
        <c:noMultiLvlLbl val="0"/>
      </c:catAx>
      <c:valAx>
        <c:axId val="210551936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ko-KR"/>
          </a:p>
        </c:txPr>
        <c:crossAx val="20393062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C1F-4056-A8C9-8243E8CD949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C1F-4056-A8C9-8243E8CD949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C1F-4056-A8C9-8243E8CD949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C1F-4056-A8C9-8243E8CD9496}"/>
              </c:ext>
            </c:extLst>
          </c:dPt>
          <c:errBars>
            <c:errBarType val="plus"/>
            <c:errValType val="cust"/>
            <c:noEndCap val="0"/>
            <c:plus>
              <c:numRef>
                <c:f>'CRABP2-INVASION'!$C$44:$C$46</c:f>
                <c:numCache>
                  <c:formatCode>General</c:formatCode>
                  <c:ptCount val="3"/>
                  <c:pt idx="0">
                    <c:v>1.7141228971096743E-2</c:v>
                  </c:pt>
                  <c:pt idx="1">
                    <c:v>1.4301332616829181E-2</c:v>
                  </c:pt>
                  <c:pt idx="2">
                    <c:v>1.57698317654161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/>
            </c:spPr>
          </c:errBars>
          <c:cat>
            <c:strRef>
              <c:f>'CRABP2-INVASION'!$A$44:$A$46</c:f>
              <c:strCache>
                <c:ptCount val="3"/>
                <c:pt idx="0">
                  <c:v>siCon</c:v>
                </c:pt>
                <c:pt idx="1">
                  <c:v>siCRABP2-1</c:v>
                </c:pt>
                <c:pt idx="2">
                  <c:v>siCRABP2-2</c:v>
                </c:pt>
              </c:strCache>
            </c:strRef>
          </c:cat>
          <c:val>
            <c:numRef>
              <c:f>'CRABP2-INVASION'!$B$44:$B$46</c:f>
              <c:numCache>
                <c:formatCode>0.00_ </c:formatCode>
                <c:ptCount val="3"/>
                <c:pt idx="0">
                  <c:v>1</c:v>
                </c:pt>
                <c:pt idx="1">
                  <c:v>0.40556990040575436</c:v>
                </c:pt>
                <c:pt idx="2">
                  <c:v>0.407967539653264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9C1F-4056-A8C9-8243E8CD94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7271168"/>
        <c:axId val="202939712"/>
      </c:barChart>
      <c:catAx>
        <c:axId val="1472711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02939712"/>
        <c:crosses val="autoZero"/>
        <c:auto val="1"/>
        <c:lblAlgn val="ctr"/>
        <c:lblOffset val="100"/>
        <c:noMultiLvlLbl val="0"/>
      </c:catAx>
      <c:valAx>
        <c:axId val="202939712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727116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roliferation (CRABP2)'!$K$39</c:f>
              <c:strCache>
                <c:ptCount val="1"/>
                <c:pt idx="0">
                  <c:v>siControl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CRABP2)'!$P$39:$S$39</c:f>
                <c:numCache>
                  <c:formatCode>General</c:formatCode>
                  <c:ptCount val="4"/>
                  <c:pt idx="0">
                    <c:v>4.574043979168791E-2</c:v>
                  </c:pt>
                  <c:pt idx="1">
                    <c:v>7.1218705821245454E-2</c:v>
                  </c:pt>
                  <c:pt idx="2">
                    <c:v>5.3305142478705471E-2</c:v>
                  </c:pt>
                  <c:pt idx="3">
                    <c:v>0.2467237205828027</c:v>
                  </c:pt>
                </c:numCache>
              </c:numRef>
            </c:plus>
            <c:minus>
              <c:numRef>
                <c:f>'proliferation (CRABP2)'!$P$39:$S$39</c:f>
                <c:numCache>
                  <c:formatCode>General</c:formatCode>
                  <c:ptCount val="4"/>
                  <c:pt idx="0">
                    <c:v>4.574043979168791E-2</c:v>
                  </c:pt>
                  <c:pt idx="1">
                    <c:v>7.1218705821245454E-2</c:v>
                  </c:pt>
                  <c:pt idx="2">
                    <c:v>5.3305142478705471E-2</c:v>
                  </c:pt>
                  <c:pt idx="3">
                    <c:v>0.2467237205828027</c:v>
                  </c:pt>
                </c:numCache>
              </c:numRef>
            </c:minus>
          </c:errBars>
          <c:cat>
            <c:numRef>
              <c:f>'proliferation (CRABP2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CRABP2)'!$L$39:$O$39</c:f>
              <c:numCache>
                <c:formatCode>0.00</c:formatCode>
                <c:ptCount val="4"/>
                <c:pt idx="0">
                  <c:v>1</c:v>
                </c:pt>
                <c:pt idx="1">
                  <c:v>2.344763237695358</c:v>
                </c:pt>
                <c:pt idx="2">
                  <c:v>4.3799860041987406</c:v>
                </c:pt>
                <c:pt idx="3">
                  <c:v>5.4324702589223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3B9-45A5-9800-D6344FC2CBB7}"/>
            </c:ext>
          </c:extLst>
        </c:ser>
        <c:ser>
          <c:idx val="1"/>
          <c:order val="1"/>
          <c:tx>
            <c:strRef>
              <c:f>'proliferation (CRABP2)'!$K$40</c:f>
              <c:strCache>
                <c:ptCount val="1"/>
                <c:pt idx="0">
                  <c:v>siCRABP2-1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  <a:prstDash val="dash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CRABP2)'!$P$40:$S$40</c:f>
                <c:numCache>
                  <c:formatCode>General</c:formatCode>
                  <c:ptCount val="4"/>
                  <c:pt idx="0">
                    <c:v>1.3307028273800842E-2</c:v>
                  </c:pt>
                  <c:pt idx="1">
                    <c:v>7.0271607181654858E-2</c:v>
                  </c:pt>
                  <c:pt idx="2">
                    <c:v>0.20860370686444663</c:v>
                  </c:pt>
                  <c:pt idx="3">
                    <c:v>0.32428066696324309</c:v>
                  </c:pt>
                </c:numCache>
              </c:numRef>
            </c:plus>
            <c:minus>
              <c:numRef>
                <c:f>'proliferation (CRABP2)'!$P$40:$S$40</c:f>
                <c:numCache>
                  <c:formatCode>General</c:formatCode>
                  <c:ptCount val="4"/>
                  <c:pt idx="0">
                    <c:v>1.3307028273800842E-2</c:v>
                  </c:pt>
                  <c:pt idx="1">
                    <c:v>7.0271607181654858E-2</c:v>
                  </c:pt>
                  <c:pt idx="2">
                    <c:v>0.20860370686444663</c:v>
                  </c:pt>
                  <c:pt idx="3">
                    <c:v>0.32428066696324309</c:v>
                  </c:pt>
                </c:numCache>
              </c:numRef>
            </c:minus>
          </c:errBars>
          <c:cat>
            <c:numRef>
              <c:f>'proliferation (CRABP2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CRABP2)'!$L$40:$O$40</c:f>
              <c:numCache>
                <c:formatCode>0.00</c:formatCode>
                <c:ptCount val="4"/>
                <c:pt idx="0">
                  <c:v>1</c:v>
                </c:pt>
                <c:pt idx="1">
                  <c:v>2.1507868383404865</c:v>
                </c:pt>
                <c:pt idx="2">
                  <c:v>4.1845493562231759</c:v>
                </c:pt>
                <c:pt idx="3">
                  <c:v>5.113304721030043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B9-45A5-9800-D6344FC2CBB7}"/>
            </c:ext>
          </c:extLst>
        </c:ser>
        <c:ser>
          <c:idx val="2"/>
          <c:order val="2"/>
          <c:tx>
            <c:strRef>
              <c:f>'proliferation (CRABP2)'!$K$41</c:f>
              <c:strCache>
                <c:ptCount val="1"/>
                <c:pt idx="0">
                  <c:v>siCRABP2-2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CRABP2)'!$P$41:$S$41</c:f>
                <c:numCache>
                  <c:formatCode>General</c:formatCode>
                  <c:ptCount val="4"/>
                  <c:pt idx="0">
                    <c:v>1.4639416808567694E-2</c:v>
                  </c:pt>
                  <c:pt idx="1">
                    <c:v>4.3905610988820704E-2</c:v>
                  </c:pt>
                  <c:pt idx="2">
                    <c:v>0.20910667428256446</c:v>
                  </c:pt>
                  <c:pt idx="3">
                    <c:v>0.18225663021809385</c:v>
                  </c:pt>
                </c:numCache>
              </c:numRef>
            </c:plus>
            <c:minus>
              <c:numRef>
                <c:f>'proliferation (CRABP2)'!$P$41:$S$41</c:f>
                <c:numCache>
                  <c:formatCode>General</c:formatCode>
                  <c:ptCount val="4"/>
                  <c:pt idx="0">
                    <c:v>1.4639416808567694E-2</c:v>
                  </c:pt>
                  <c:pt idx="1">
                    <c:v>4.3905610988820704E-2</c:v>
                  </c:pt>
                  <c:pt idx="2">
                    <c:v>0.20910667428256446</c:v>
                  </c:pt>
                  <c:pt idx="3">
                    <c:v>0.18225663021809385</c:v>
                  </c:pt>
                </c:numCache>
              </c:numRef>
            </c:minus>
          </c:errBars>
          <c:cat>
            <c:numRef>
              <c:f>'proliferation (CRABP2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CRABP2)'!$L$41:$O$41</c:f>
              <c:numCache>
                <c:formatCode>0.00</c:formatCode>
                <c:ptCount val="4"/>
                <c:pt idx="0">
                  <c:v>1</c:v>
                </c:pt>
                <c:pt idx="1">
                  <c:v>2.2704026115342764</c:v>
                </c:pt>
                <c:pt idx="2">
                  <c:v>4.4243743199129488</c:v>
                </c:pt>
                <c:pt idx="3">
                  <c:v>5.563656147986942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3B9-45A5-9800-D6344FC2CB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8469248"/>
        <c:axId val="148742720"/>
      </c:lineChart>
      <c:catAx>
        <c:axId val="148469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742720"/>
        <c:crosses val="autoZero"/>
        <c:auto val="1"/>
        <c:lblAlgn val="ctr"/>
        <c:lblOffset val="100"/>
        <c:noMultiLvlLbl val="0"/>
      </c:catAx>
      <c:valAx>
        <c:axId val="148742720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4692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7.2233861247732067E-2"/>
          <c:y val="5.5484567901234565E-2"/>
          <c:w val="0.55757771188514493"/>
          <c:h val="0.31674545454545455"/>
        </c:manualLayout>
      </c:layout>
      <c:overlay val="1"/>
      <c:txPr>
        <a:bodyPr/>
        <a:lstStyle/>
        <a:p>
          <a:pPr>
            <a:defRPr sz="800"/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FFB-475C-B17E-49DDF06C360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FFB-475C-B17E-49DDF06C360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FFB-475C-B17E-49DDF06C360B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FFB-475C-B17E-49DDF06C360B}"/>
              </c:ext>
            </c:extLst>
          </c:dPt>
          <c:errBars>
            <c:errBarType val="plus"/>
            <c:errValType val="cust"/>
            <c:noEndCap val="0"/>
            <c:plus>
              <c:numRef>
                <c:f>'FNDC4-INVASION'!$C$44:$C$46</c:f>
                <c:numCache>
                  <c:formatCode>General</c:formatCode>
                  <c:ptCount val="3"/>
                  <c:pt idx="0">
                    <c:v>1.7141228971096743E-2</c:v>
                  </c:pt>
                  <c:pt idx="1">
                    <c:v>2.6779151465161084E-2</c:v>
                  </c:pt>
                  <c:pt idx="2">
                    <c:v>1.752832033653232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/>
            </c:spPr>
          </c:errBars>
          <c:cat>
            <c:strRef>
              <c:f>'FNDC4-INVASION'!$A$44:$A$46</c:f>
              <c:strCache>
                <c:ptCount val="3"/>
                <c:pt idx="0">
                  <c:v>siCon</c:v>
                </c:pt>
                <c:pt idx="1">
                  <c:v>siFNDC4-1</c:v>
                </c:pt>
                <c:pt idx="2">
                  <c:v>siFNDC4-2</c:v>
                </c:pt>
              </c:strCache>
            </c:strRef>
          </c:cat>
          <c:val>
            <c:numRef>
              <c:f>'FNDC4-INVASION'!$B$44:$B$46</c:f>
              <c:numCache>
                <c:formatCode>0.00_ </c:formatCode>
                <c:ptCount val="3"/>
                <c:pt idx="0">
                  <c:v>1</c:v>
                </c:pt>
                <c:pt idx="1">
                  <c:v>0.45721136112135735</c:v>
                </c:pt>
                <c:pt idx="2">
                  <c:v>0.441903356694946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FFB-475C-B17E-49DDF06C36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8469760"/>
        <c:axId val="148744448"/>
      </c:barChart>
      <c:catAx>
        <c:axId val="148469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744448"/>
        <c:crosses val="autoZero"/>
        <c:auto val="1"/>
        <c:lblAlgn val="ctr"/>
        <c:lblOffset val="100"/>
        <c:noMultiLvlLbl val="0"/>
      </c:catAx>
      <c:valAx>
        <c:axId val="148744448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46976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roliferation (FNDC4)'!$K$39</c:f>
              <c:strCache>
                <c:ptCount val="1"/>
                <c:pt idx="0">
                  <c:v>siControl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FNDC4)'!$P$39:$S$39</c:f>
                <c:numCache>
                  <c:formatCode>General</c:formatCode>
                  <c:ptCount val="4"/>
                  <c:pt idx="0">
                    <c:v>4.574043979168791E-2</c:v>
                  </c:pt>
                  <c:pt idx="1">
                    <c:v>7.1218705821245454E-2</c:v>
                  </c:pt>
                  <c:pt idx="2">
                    <c:v>5.3305142478705471E-2</c:v>
                  </c:pt>
                  <c:pt idx="3">
                    <c:v>0.2467237205828027</c:v>
                  </c:pt>
                </c:numCache>
              </c:numRef>
            </c:plus>
            <c:minus>
              <c:numRef>
                <c:f>'proliferation (FNDC4)'!$P$39:$S$39</c:f>
                <c:numCache>
                  <c:formatCode>General</c:formatCode>
                  <c:ptCount val="4"/>
                  <c:pt idx="0">
                    <c:v>4.574043979168791E-2</c:v>
                  </c:pt>
                  <c:pt idx="1">
                    <c:v>7.1218705821245454E-2</c:v>
                  </c:pt>
                  <c:pt idx="2">
                    <c:v>5.3305142478705471E-2</c:v>
                  </c:pt>
                  <c:pt idx="3">
                    <c:v>0.2467237205828027</c:v>
                  </c:pt>
                </c:numCache>
              </c:numRef>
            </c:minus>
          </c:errBars>
          <c:cat>
            <c:numRef>
              <c:f>'proliferation (FNDC4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FNDC4)'!$L$39:$O$39</c:f>
              <c:numCache>
                <c:formatCode>0.00</c:formatCode>
                <c:ptCount val="4"/>
                <c:pt idx="0">
                  <c:v>1</c:v>
                </c:pt>
                <c:pt idx="1">
                  <c:v>2.344763237695358</c:v>
                </c:pt>
                <c:pt idx="2">
                  <c:v>4.3799860041987406</c:v>
                </c:pt>
                <c:pt idx="3">
                  <c:v>5.4324702589223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81D-4E13-B0EF-AE22AFF4B665}"/>
            </c:ext>
          </c:extLst>
        </c:ser>
        <c:ser>
          <c:idx val="1"/>
          <c:order val="1"/>
          <c:tx>
            <c:strRef>
              <c:f>'proliferation (FNDC4)'!$K$40</c:f>
              <c:strCache>
                <c:ptCount val="1"/>
                <c:pt idx="0">
                  <c:v>siFNDC4-1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  <a:prstDash val="dash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FNDC4)'!$P$40:$S$40</c:f>
                <c:numCache>
                  <c:formatCode>General</c:formatCode>
                  <c:ptCount val="4"/>
                  <c:pt idx="0">
                    <c:v>7.7260624850237367E-2</c:v>
                  </c:pt>
                  <c:pt idx="1">
                    <c:v>7.3974535036795172E-2</c:v>
                  </c:pt>
                  <c:pt idx="2">
                    <c:v>0.24556392975886329</c:v>
                  </c:pt>
                  <c:pt idx="3">
                    <c:v>0.48192340990076565</c:v>
                  </c:pt>
                </c:numCache>
              </c:numRef>
            </c:plus>
            <c:minus>
              <c:numRef>
                <c:f>'proliferation (FNDC4)'!$P$40:$S$40</c:f>
                <c:numCache>
                  <c:formatCode>General</c:formatCode>
                  <c:ptCount val="4"/>
                  <c:pt idx="0">
                    <c:v>7.7260624850237367E-2</c:v>
                  </c:pt>
                  <c:pt idx="1">
                    <c:v>7.3974535036795172E-2</c:v>
                  </c:pt>
                  <c:pt idx="2">
                    <c:v>0.24556392975886329</c:v>
                  </c:pt>
                  <c:pt idx="3">
                    <c:v>0.48192340990076565</c:v>
                  </c:pt>
                </c:numCache>
              </c:numRef>
            </c:minus>
          </c:errBars>
          <c:cat>
            <c:numRef>
              <c:f>'proliferation (FNDC4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FNDC4)'!$L$40:$O$40</c:f>
              <c:numCache>
                <c:formatCode>0.00</c:formatCode>
                <c:ptCount val="4"/>
                <c:pt idx="0">
                  <c:v>1</c:v>
                </c:pt>
                <c:pt idx="1">
                  <c:v>2.1755882352941178</c:v>
                </c:pt>
                <c:pt idx="2">
                  <c:v>3.9682352941176471</c:v>
                </c:pt>
                <c:pt idx="3">
                  <c:v>5.04411764705882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81D-4E13-B0EF-AE22AFF4B665}"/>
            </c:ext>
          </c:extLst>
        </c:ser>
        <c:ser>
          <c:idx val="2"/>
          <c:order val="2"/>
          <c:tx>
            <c:strRef>
              <c:f>'proliferation (FNDC4)'!$K$41</c:f>
              <c:strCache>
                <c:ptCount val="1"/>
                <c:pt idx="0">
                  <c:v>siFNDC4-2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roliferation (FNDC4)'!$P$41:$S$41</c:f>
                <c:numCache>
                  <c:formatCode>General</c:formatCode>
                  <c:ptCount val="4"/>
                  <c:pt idx="0">
                    <c:v>5.9888075847496322E-2</c:v>
                  </c:pt>
                  <c:pt idx="1">
                    <c:v>2.9249795480577639E-2</c:v>
                  </c:pt>
                  <c:pt idx="2">
                    <c:v>0.27615669807030035</c:v>
                  </c:pt>
                  <c:pt idx="3">
                    <c:v>0.13092457409984562</c:v>
                  </c:pt>
                </c:numCache>
              </c:numRef>
            </c:plus>
            <c:minus>
              <c:numRef>
                <c:f>'proliferation (FNDC4)'!$P$41:$S$41</c:f>
                <c:numCache>
                  <c:formatCode>General</c:formatCode>
                  <c:ptCount val="4"/>
                  <c:pt idx="0">
                    <c:v>5.9888075847496322E-2</c:v>
                  </c:pt>
                  <c:pt idx="1">
                    <c:v>2.9249795480577639E-2</c:v>
                  </c:pt>
                  <c:pt idx="2">
                    <c:v>0.27615669807030035</c:v>
                  </c:pt>
                  <c:pt idx="3">
                    <c:v>0.13092457409984562</c:v>
                  </c:pt>
                </c:numCache>
              </c:numRef>
            </c:minus>
          </c:errBars>
          <c:cat>
            <c:numRef>
              <c:f>'proliferation (FNDC4)'!$L$38:$O$3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proliferation (FNDC4)'!$L$41:$O$41</c:f>
              <c:numCache>
                <c:formatCode>0.00</c:formatCode>
                <c:ptCount val="4"/>
                <c:pt idx="0">
                  <c:v>1</c:v>
                </c:pt>
                <c:pt idx="1">
                  <c:v>2.1734039587398937</c:v>
                </c:pt>
                <c:pt idx="2">
                  <c:v>4.1851129077223304</c:v>
                </c:pt>
                <c:pt idx="3">
                  <c:v>5.36130471145804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81D-4E13-B0EF-AE22AFF4B6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8471296"/>
        <c:axId val="148746752"/>
      </c:lineChart>
      <c:catAx>
        <c:axId val="148471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746752"/>
        <c:crosses val="autoZero"/>
        <c:auto val="1"/>
        <c:lblAlgn val="ctr"/>
        <c:lblOffset val="100"/>
        <c:noMultiLvlLbl val="0"/>
      </c:catAx>
      <c:valAx>
        <c:axId val="148746752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484712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604305555555556"/>
          <c:y val="9.8820707070707073E-2"/>
          <c:w val="0.45518126177024482"/>
          <c:h val="0.29750303030303032"/>
        </c:manualLayout>
      </c:layout>
      <c:overlay val="1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P$2:$P$3</c:f>
                <c:numCache>
                  <c:formatCode>General</c:formatCode>
                  <c:ptCount val="2"/>
                  <c:pt idx="0">
                    <c:v>9.8832666258756752E-2</c:v>
                  </c:pt>
                  <c:pt idx="1">
                    <c:v>0.121195778565004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L$2:$L$3</c:f>
              <c:strCache>
                <c:ptCount val="2"/>
                <c:pt idx="0">
                  <c:v>shControl</c:v>
                </c:pt>
                <c:pt idx="1">
                  <c:v>shGRPR</c:v>
                </c:pt>
              </c:strCache>
            </c:strRef>
          </c:cat>
          <c:val>
            <c:numRef>
              <c:f>Sheet1!$O$2:$O$3</c:f>
              <c:numCache>
                <c:formatCode>0.0000</c:formatCode>
                <c:ptCount val="2"/>
                <c:pt idx="0">
                  <c:v>0.99999999999999989</c:v>
                </c:pt>
                <c:pt idx="1">
                  <c:v>0.134976715160365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axId val="132275200"/>
        <c:axId val="148388032"/>
      </c:barChart>
      <c:catAx>
        <c:axId val="1322752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48388032"/>
        <c:crosses val="autoZero"/>
        <c:auto val="1"/>
        <c:lblAlgn val="ctr"/>
        <c:lblOffset val="100"/>
        <c:noMultiLvlLbl val="0"/>
      </c:catAx>
      <c:valAx>
        <c:axId val="148388032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322752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7003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960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7488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6469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5977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099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1286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6531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992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6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4106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85D86-0751-4079-80AF-8D58175343BC}" type="datetimeFigureOut">
              <a:rPr lang="ko-KR" altLang="en-US" smtClean="0"/>
              <a:t>2024-1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E2F18-3992-4B35-879B-D6F30EAD9C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2826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image" Target="../media/image8.jpeg"/><Relationship Id="rId5" Type="http://schemas.openxmlformats.org/officeDocument/2006/relationships/image" Target="../media/image3.jpeg"/><Relationship Id="rId15" Type="http://schemas.openxmlformats.org/officeDocument/2006/relationships/chart" Target="../charts/chart6.xml"/><Relationship Id="rId10" Type="http://schemas.openxmlformats.org/officeDocument/2006/relationships/image" Target="../media/image7.jpeg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chart" Target="../charts/chart7.xml"/><Relationship Id="rId4" Type="http://schemas.openxmlformats.org/officeDocument/2006/relationships/image" Target="../media/image13.png"/><Relationship Id="rId9" Type="http://schemas.openxmlformats.org/officeDocument/2006/relationships/image" Target="../media/image18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0.png"/><Relationship Id="rId7" Type="http://schemas.openxmlformats.org/officeDocument/2006/relationships/image" Target="../media/image2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22.png"/><Relationship Id="rId10" Type="http://schemas.openxmlformats.org/officeDocument/2006/relationships/image" Target="../media/image26.png"/><Relationship Id="rId4" Type="http://schemas.openxmlformats.org/officeDocument/2006/relationships/image" Target="../media/image21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0.png"/><Relationship Id="rId4" Type="http://schemas.openxmlformats.org/officeDocument/2006/relationships/image" Target="../media/image3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1435" y="9355"/>
            <a:ext cx="291594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itchFamily="34" charset="0"/>
                <a:ea typeface="Gulim" panose="020B0600000101010101" pitchFamily="50" charset="-127"/>
                <a:cs typeface="Arial" pitchFamily="34" charset="0"/>
              </a:rPr>
              <a:t>Fig. S1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10689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75856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342088" y="745847"/>
            <a:ext cx="2844000" cy="1764008"/>
            <a:chOff x="0" y="-94600"/>
            <a:chExt cx="1866900" cy="2317465"/>
          </a:xfrm>
        </p:grpSpPr>
        <p:graphicFrame>
          <p:nvGraphicFramePr>
            <p:cNvPr id="8" name="차트 7"/>
            <p:cNvGraphicFramePr>
              <a:graphicFrameLocks/>
            </p:cNvGraphicFramePr>
            <p:nvPr/>
          </p:nvGraphicFramePr>
          <p:xfrm>
            <a:off x="129540" y="137160"/>
            <a:ext cx="1737360" cy="20857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9" name="그룹 8"/>
            <p:cNvGrpSpPr/>
            <p:nvPr/>
          </p:nvGrpSpPr>
          <p:grpSpPr>
            <a:xfrm>
              <a:off x="0" y="-94600"/>
              <a:ext cx="1812563" cy="1971620"/>
              <a:chOff x="0" y="-105114"/>
              <a:chExt cx="2742137" cy="2190743"/>
            </a:xfrm>
          </p:grpSpPr>
          <p:grpSp>
            <p:nvGrpSpPr>
              <p:cNvPr id="10" name="그룹 9"/>
              <p:cNvGrpSpPr/>
              <p:nvPr/>
            </p:nvGrpSpPr>
            <p:grpSpPr>
              <a:xfrm>
                <a:off x="0" y="-105114"/>
                <a:ext cx="2742137" cy="1133985"/>
                <a:chOff x="0" y="-109575"/>
                <a:chExt cx="2744214" cy="1182110"/>
              </a:xfrm>
            </p:grpSpPr>
            <p:sp>
              <p:nvSpPr>
                <p:cNvPr id="12" name="TextBox 6"/>
                <p:cNvSpPr txBox="1"/>
                <p:nvPr/>
              </p:nvSpPr>
              <p:spPr>
                <a:xfrm>
                  <a:off x="0" y="-109575"/>
                  <a:ext cx="1864590" cy="2438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RADP2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8"/>
                <p:cNvSpPr txBox="1"/>
                <p:nvPr/>
              </p:nvSpPr>
              <p:spPr>
                <a:xfrm>
                  <a:off x="1473140" y="701732"/>
                  <a:ext cx="575238" cy="205739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ko-KR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8"/>
                <p:cNvSpPr txBox="1"/>
                <p:nvPr/>
              </p:nvSpPr>
              <p:spPr>
                <a:xfrm>
                  <a:off x="2168974" y="866795"/>
                  <a:ext cx="575240" cy="2057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ko-KR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" name="TextBox 56"/>
              <p:cNvSpPr txBox="1"/>
              <p:nvPr/>
            </p:nvSpPr>
            <p:spPr>
              <a:xfrm rot="16200000">
                <a:off x="-742646" y="1067084"/>
                <a:ext cx="1789441" cy="2476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5" name="그룹 14"/>
          <p:cNvGrpSpPr/>
          <p:nvPr/>
        </p:nvGrpSpPr>
        <p:grpSpPr>
          <a:xfrm>
            <a:off x="3402112" y="738436"/>
            <a:ext cx="2844000" cy="1790675"/>
            <a:chOff x="0" y="-129634"/>
            <a:chExt cx="1866900" cy="2352499"/>
          </a:xfrm>
        </p:grpSpPr>
        <p:graphicFrame>
          <p:nvGraphicFramePr>
            <p:cNvPr id="16" name="차트 15"/>
            <p:cNvGraphicFramePr>
              <a:graphicFrameLocks/>
            </p:cNvGraphicFramePr>
            <p:nvPr/>
          </p:nvGraphicFramePr>
          <p:xfrm>
            <a:off x="129540" y="137160"/>
            <a:ext cx="1737360" cy="20857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7" name="그룹 16"/>
            <p:cNvGrpSpPr/>
            <p:nvPr/>
          </p:nvGrpSpPr>
          <p:grpSpPr>
            <a:xfrm>
              <a:off x="0" y="-129634"/>
              <a:ext cx="1812562" cy="2006653"/>
              <a:chOff x="0" y="-144041"/>
              <a:chExt cx="2742135" cy="2229670"/>
            </a:xfrm>
          </p:grpSpPr>
          <p:grpSp>
            <p:nvGrpSpPr>
              <p:cNvPr id="18" name="그룹 17"/>
              <p:cNvGrpSpPr/>
              <p:nvPr/>
            </p:nvGrpSpPr>
            <p:grpSpPr>
              <a:xfrm>
                <a:off x="0" y="-144041"/>
                <a:ext cx="2742135" cy="1242434"/>
                <a:chOff x="0" y="-150154"/>
                <a:chExt cx="2744212" cy="1295161"/>
              </a:xfrm>
            </p:grpSpPr>
            <p:sp>
              <p:nvSpPr>
                <p:cNvPr id="20" name="TextBox 6"/>
                <p:cNvSpPr txBox="1"/>
                <p:nvPr/>
              </p:nvSpPr>
              <p:spPr>
                <a:xfrm>
                  <a:off x="0" y="-150154"/>
                  <a:ext cx="1864590" cy="2438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NDC4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8"/>
                <p:cNvSpPr txBox="1"/>
                <p:nvPr/>
              </p:nvSpPr>
              <p:spPr>
                <a:xfrm>
                  <a:off x="1463673" y="933641"/>
                  <a:ext cx="575238" cy="2057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ko-KR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8"/>
                <p:cNvSpPr txBox="1"/>
                <p:nvPr/>
              </p:nvSpPr>
              <p:spPr>
                <a:xfrm>
                  <a:off x="2168972" y="939267"/>
                  <a:ext cx="575240" cy="2057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ko-KR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" name="TextBox 56"/>
              <p:cNvSpPr txBox="1"/>
              <p:nvPr/>
            </p:nvSpPr>
            <p:spPr>
              <a:xfrm rot="16200000">
                <a:off x="-742646" y="1067084"/>
                <a:ext cx="1789441" cy="24765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771686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0689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87294" y="689888"/>
            <a:ext cx="795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Control</a:t>
            </a:r>
            <a:endParaRPr lang="en-US" altLang="ko-KR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14328" y="613577"/>
            <a:ext cx="752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CRABP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0365" y="999805"/>
            <a:ext cx="734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RABP2</a:t>
            </a:r>
            <a:endParaRPr lang="ko-KR" altLang="en-US" sz="9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261236" y="1344611"/>
            <a:ext cx="5325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</a:t>
            </a: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ctin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1172424" y="790637"/>
            <a:ext cx="4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003792" y="765643"/>
            <a:ext cx="6994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 1          2</a:t>
            </a:r>
          </a:p>
        </p:txBody>
      </p:sp>
      <p:grpSp>
        <p:nvGrpSpPr>
          <p:cNvPr id="9" name="그룹 8"/>
          <p:cNvGrpSpPr/>
          <p:nvPr/>
        </p:nvGrpSpPr>
        <p:grpSpPr>
          <a:xfrm>
            <a:off x="240828" y="1804649"/>
            <a:ext cx="2325617" cy="1380049"/>
            <a:chOff x="-24543" y="-84442"/>
            <a:chExt cx="2640422" cy="1386501"/>
          </a:xfrm>
        </p:grpSpPr>
        <p:graphicFrame>
          <p:nvGraphicFramePr>
            <p:cNvPr id="10" name="차트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28155756"/>
                </p:ext>
              </p:extLst>
            </p:nvPr>
          </p:nvGraphicFramePr>
          <p:xfrm>
            <a:off x="106280" y="0"/>
            <a:ext cx="2509599" cy="13020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1" name="그룹 10"/>
            <p:cNvGrpSpPr/>
            <p:nvPr/>
          </p:nvGrpSpPr>
          <p:grpSpPr>
            <a:xfrm>
              <a:off x="-24543" y="-84442"/>
              <a:ext cx="2371809" cy="1219685"/>
              <a:chOff x="-24022" y="-115419"/>
              <a:chExt cx="2321452" cy="1462651"/>
            </a:xfrm>
          </p:grpSpPr>
          <p:grpSp>
            <p:nvGrpSpPr>
              <p:cNvPr id="12" name="그룹 11"/>
              <p:cNvGrpSpPr/>
              <p:nvPr/>
            </p:nvGrpSpPr>
            <p:grpSpPr>
              <a:xfrm>
                <a:off x="1331095" y="691070"/>
                <a:ext cx="966335" cy="199320"/>
                <a:chOff x="1331095" y="691070"/>
                <a:chExt cx="966335" cy="199320"/>
              </a:xfrm>
            </p:grpSpPr>
            <p:sp>
              <p:nvSpPr>
                <p:cNvPr id="14" name="직사각형 13"/>
                <p:cNvSpPr/>
                <p:nvPr/>
              </p:nvSpPr>
              <p:spPr bwMode="auto">
                <a:xfrm>
                  <a:off x="1331095" y="691070"/>
                  <a:ext cx="312420" cy="144779"/>
                </a:xfrm>
                <a:prstGeom prst="rect">
                  <a:avLst/>
                </a:prstGeom>
                <a:noFill/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wrap="square" lIns="18288" tIns="0" rIns="0" bIns="0" rtlCol="0" anchor="t" upright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ko-KR" sz="1000" b="1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***</a:t>
                  </a:r>
                  <a:endParaRPr lang="ko-KR" altLang="en-US" sz="1000" b="1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직사각형 14"/>
                <p:cNvSpPr/>
                <p:nvPr/>
              </p:nvSpPr>
              <p:spPr bwMode="auto">
                <a:xfrm>
                  <a:off x="1985012" y="706572"/>
                  <a:ext cx="312418" cy="183818"/>
                </a:xfrm>
                <a:prstGeom prst="rect">
                  <a:avLst/>
                </a:prstGeom>
                <a:noFill/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wrap="square" lIns="18288" tIns="0" rIns="0" bIns="0" rtlCol="0" anchor="t" upright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ko-KR" sz="1000" b="1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***</a:t>
                  </a:r>
                  <a:endParaRPr lang="ko-KR" altLang="en-US" sz="1000" b="1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TextBox 199"/>
              <p:cNvSpPr txBox="1"/>
              <p:nvPr/>
            </p:nvSpPr>
            <p:spPr>
              <a:xfrm rot="16200000">
                <a:off x="-627091" y="487650"/>
                <a:ext cx="1462651" cy="256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900">
                    <a:latin typeface="Arial" panose="020B0604020202020204" pitchFamily="34" charset="0"/>
                    <a:cs typeface="Arial" panose="020B0604020202020204" pitchFamily="34" charset="0"/>
                  </a:rPr>
                  <a:t>Relative cell count</a:t>
                </a:r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6" name="그룹 15"/>
          <p:cNvGrpSpPr>
            <a:grpSpLocks noChangeAspect="1"/>
          </p:cNvGrpSpPr>
          <p:nvPr/>
        </p:nvGrpSpPr>
        <p:grpSpPr>
          <a:xfrm>
            <a:off x="714745" y="3156019"/>
            <a:ext cx="540000" cy="360000"/>
            <a:chOff x="2737296" y="3581690"/>
            <a:chExt cx="648000" cy="432000"/>
          </a:xfrm>
        </p:grpSpPr>
        <p:pic>
          <p:nvPicPr>
            <p:cNvPr id="17" name="Picture 5" descr="C:\Users\NCC_YJK_CEY\Desktop\2024.07.30-a427-si-c,f-2차\Snap-4947-Image Export-06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37296" y="3581690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8" name="직선 연결선 17"/>
            <p:cNvCxnSpPr/>
            <p:nvPr/>
          </p:nvCxnSpPr>
          <p:spPr>
            <a:xfrm>
              <a:off x="3258604" y="3970186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그룹 18"/>
          <p:cNvGrpSpPr>
            <a:grpSpLocks noChangeAspect="1"/>
          </p:cNvGrpSpPr>
          <p:nvPr/>
        </p:nvGrpSpPr>
        <p:grpSpPr>
          <a:xfrm>
            <a:off x="1314596" y="3156019"/>
            <a:ext cx="540000" cy="360000"/>
            <a:chOff x="3422872" y="3581690"/>
            <a:chExt cx="648000" cy="432000"/>
          </a:xfrm>
        </p:grpSpPr>
        <p:pic>
          <p:nvPicPr>
            <p:cNvPr id="20" name="Picture 6" descr="C:\Users\NCC_YJK_CEY\Desktop\2024.07.30-a427-si-c,f-2차\Snap-4955-Image Export-14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2872" y="3581690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1" name="직선 연결선 20"/>
            <p:cNvCxnSpPr/>
            <p:nvPr/>
          </p:nvCxnSpPr>
          <p:spPr>
            <a:xfrm>
              <a:off x="3936400" y="3967186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그룹 21"/>
          <p:cNvGrpSpPr>
            <a:grpSpLocks noChangeAspect="1"/>
          </p:cNvGrpSpPr>
          <p:nvPr/>
        </p:nvGrpSpPr>
        <p:grpSpPr>
          <a:xfrm>
            <a:off x="1900781" y="3156019"/>
            <a:ext cx="540000" cy="360000"/>
            <a:chOff x="4114074" y="3581690"/>
            <a:chExt cx="648000" cy="432000"/>
          </a:xfrm>
        </p:grpSpPr>
        <p:pic>
          <p:nvPicPr>
            <p:cNvPr id="23" name="Picture 7" descr="C:\Users\NCC_YJK_CEY\Desktop\2024.07.30-a427-si-c,f-2차\Snap-4964-Image Export-23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14074" y="3581690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4" name="직선 연결선 23"/>
            <p:cNvCxnSpPr/>
            <p:nvPr/>
          </p:nvCxnSpPr>
          <p:spPr>
            <a:xfrm>
              <a:off x="4630602" y="3970186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24"/>
          <p:cNvGrpSpPr/>
          <p:nvPr/>
        </p:nvGrpSpPr>
        <p:grpSpPr>
          <a:xfrm>
            <a:off x="243645" y="4005256"/>
            <a:ext cx="2304000" cy="1728000"/>
            <a:chOff x="-58754" y="191040"/>
            <a:chExt cx="3795949" cy="2096053"/>
          </a:xfrm>
        </p:grpSpPr>
        <p:graphicFrame>
          <p:nvGraphicFramePr>
            <p:cNvPr id="26" name="차트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30241857"/>
                </p:ext>
              </p:extLst>
            </p:nvPr>
          </p:nvGraphicFramePr>
          <p:xfrm>
            <a:off x="144877" y="191040"/>
            <a:ext cx="3592318" cy="19650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27" name="그룹 26"/>
            <p:cNvGrpSpPr/>
            <p:nvPr/>
          </p:nvGrpSpPr>
          <p:grpSpPr>
            <a:xfrm>
              <a:off x="-58754" y="357515"/>
              <a:ext cx="2730210" cy="1929578"/>
              <a:chOff x="-58754" y="130469"/>
              <a:chExt cx="2730210" cy="4823952"/>
            </a:xfrm>
          </p:grpSpPr>
          <p:sp>
            <p:nvSpPr>
              <p:cNvPr id="28" name="직사각형 27"/>
              <p:cNvSpPr/>
              <p:nvPr/>
            </p:nvSpPr>
            <p:spPr>
              <a:xfrm rot="16200000">
                <a:off x="-1791908" y="1863623"/>
                <a:ext cx="3806363" cy="34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Relative intensity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29" name="직사각형 28"/>
              <p:cNvSpPr/>
              <p:nvPr/>
            </p:nvSpPr>
            <p:spPr>
              <a:xfrm>
                <a:off x="1653898" y="4236725"/>
                <a:ext cx="1017558" cy="71769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Days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0" name="직사각형 29"/>
          <p:cNvSpPr/>
          <p:nvPr/>
        </p:nvSpPr>
        <p:spPr>
          <a:xfrm>
            <a:off x="71435" y="9355"/>
            <a:ext cx="291594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itchFamily="34" charset="0"/>
                <a:ea typeface="Gulim" panose="020B0600000101010101" pitchFamily="50" charset="-127"/>
                <a:cs typeface="Arial" pitchFamily="34" charset="0"/>
              </a:rPr>
              <a:t>Fig. S2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01" t="20884" r="33020" b="40889"/>
          <a:stretch/>
        </p:blipFill>
        <p:spPr bwMode="auto">
          <a:xfrm rot="5400000" flipH="1" flipV="1">
            <a:off x="1127478" y="1068255"/>
            <a:ext cx="274006" cy="89388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3" t="19458" r="51322" b="43003"/>
          <a:stretch/>
        </p:blipFill>
        <p:spPr bwMode="auto">
          <a:xfrm rot="5400000" flipH="1" flipV="1">
            <a:off x="1128733" y="644948"/>
            <a:ext cx="271493" cy="893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3660874" y="686888"/>
            <a:ext cx="795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Control</a:t>
            </a:r>
            <a:endParaRPr lang="en-US" altLang="ko-KR" sz="8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087908" y="610577"/>
            <a:ext cx="752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iFNDC4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323945" y="996805"/>
            <a:ext cx="734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NDC4</a:t>
            </a:r>
            <a:endParaRPr lang="ko-KR" altLang="en-US" sz="9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3334816" y="1344611"/>
            <a:ext cx="5325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</a:t>
            </a:r>
            <a:r>
              <a:rPr lang="en-US" altLang="ko-KR" sz="9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ctin</a:t>
            </a:r>
            <a:endParaRPr lang="ko-KR" altLang="en-US" sz="9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>
            <a:off x="4246004" y="787637"/>
            <a:ext cx="4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4077372" y="762643"/>
            <a:ext cx="6994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 1          2</a:t>
            </a:r>
          </a:p>
        </p:txBody>
      </p:sp>
      <p:grpSp>
        <p:nvGrpSpPr>
          <p:cNvPr id="39" name="그룹 38"/>
          <p:cNvGrpSpPr>
            <a:grpSpLocks noChangeAspect="1"/>
          </p:cNvGrpSpPr>
          <p:nvPr/>
        </p:nvGrpSpPr>
        <p:grpSpPr>
          <a:xfrm>
            <a:off x="3780582" y="3156019"/>
            <a:ext cx="540000" cy="360000"/>
            <a:chOff x="5248701" y="3581268"/>
            <a:chExt cx="648000" cy="432000"/>
          </a:xfrm>
        </p:grpSpPr>
        <p:pic>
          <p:nvPicPr>
            <p:cNvPr id="40" name="Picture 3" descr="C:\Users\NCC_YJK_CEY\Desktop\2024.07.30-a427-si-c,f-2차\Snap-4943-Image Export-02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8701" y="3581268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1" name="직선 연결선 40"/>
            <p:cNvCxnSpPr/>
            <p:nvPr/>
          </p:nvCxnSpPr>
          <p:spPr>
            <a:xfrm>
              <a:off x="5775884" y="3970560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그룹 41"/>
          <p:cNvGrpSpPr>
            <a:grpSpLocks noChangeAspect="1"/>
          </p:cNvGrpSpPr>
          <p:nvPr/>
        </p:nvGrpSpPr>
        <p:grpSpPr>
          <a:xfrm>
            <a:off x="4368852" y="3156019"/>
            <a:ext cx="540000" cy="360000"/>
            <a:chOff x="5943152" y="3581268"/>
            <a:chExt cx="648000" cy="432000"/>
          </a:xfrm>
        </p:grpSpPr>
        <p:pic>
          <p:nvPicPr>
            <p:cNvPr id="43" name="Picture 4" descr="C:\Users\NCC_YJK_CEY\Desktop\2024.07.30-a427-si-c,f-2차\Snap-4970-Image Export-29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43152" y="3581268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4" name="직선 연결선 43"/>
            <p:cNvCxnSpPr/>
            <p:nvPr/>
          </p:nvCxnSpPr>
          <p:spPr>
            <a:xfrm>
              <a:off x="6453680" y="3967560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그룹 44"/>
          <p:cNvGrpSpPr>
            <a:grpSpLocks noChangeAspect="1"/>
          </p:cNvGrpSpPr>
          <p:nvPr/>
        </p:nvGrpSpPr>
        <p:grpSpPr>
          <a:xfrm>
            <a:off x="4950249" y="3156019"/>
            <a:ext cx="540000" cy="360000"/>
            <a:chOff x="6635406" y="3581268"/>
            <a:chExt cx="648000" cy="432000"/>
          </a:xfrm>
        </p:grpSpPr>
        <p:pic>
          <p:nvPicPr>
            <p:cNvPr id="46" name="Picture 2" descr="C:\Users\NCC_YJK_CEY\Desktop\2024.07.30-a427-si-c,f-2차\Snap-4980-Image Export-39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35406" y="3581268"/>
              <a:ext cx="648000" cy="4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7" name="직선 연결선 46"/>
            <p:cNvCxnSpPr/>
            <p:nvPr/>
          </p:nvCxnSpPr>
          <p:spPr>
            <a:xfrm>
              <a:off x="7147882" y="3970560"/>
              <a:ext cx="85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8" name="Picture 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3" t="34546" r="57530"/>
          <a:stretch/>
        </p:blipFill>
        <p:spPr bwMode="auto">
          <a:xfrm rot="5400000" flipH="1" flipV="1">
            <a:off x="4148689" y="1091256"/>
            <a:ext cx="274004" cy="84789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55" t="24498" r="18091"/>
          <a:stretch/>
        </p:blipFill>
        <p:spPr bwMode="auto">
          <a:xfrm rot="5400000" flipH="1" flipV="1">
            <a:off x="4135548" y="666825"/>
            <a:ext cx="292722" cy="8496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0" name="그룹 49"/>
          <p:cNvGrpSpPr/>
          <p:nvPr/>
        </p:nvGrpSpPr>
        <p:grpSpPr>
          <a:xfrm>
            <a:off x="3324726" y="1844950"/>
            <a:ext cx="2327394" cy="1337337"/>
            <a:chOff x="-10231" y="-38632"/>
            <a:chExt cx="2317787" cy="1249847"/>
          </a:xfrm>
        </p:grpSpPr>
        <p:graphicFrame>
          <p:nvGraphicFramePr>
            <p:cNvPr id="51" name="차트 50"/>
            <p:cNvGraphicFramePr>
              <a:graphicFrameLocks/>
            </p:cNvGraphicFramePr>
            <p:nvPr/>
          </p:nvGraphicFramePr>
          <p:xfrm>
            <a:off x="106280" y="0"/>
            <a:ext cx="2201276" cy="12112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pSp>
          <p:nvGrpSpPr>
            <p:cNvPr id="52" name="그룹 51"/>
            <p:cNvGrpSpPr/>
            <p:nvPr/>
          </p:nvGrpSpPr>
          <p:grpSpPr>
            <a:xfrm>
              <a:off x="-10231" y="-38632"/>
              <a:ext cx="2093989" cy="1112017"/>
              <a:chOff x="-10014" y="-60483"/>
              <a:chExt cx="2049533" cy="1333540"/>
            </a:xfrm>
          </p:grpSpPr>
          <p:grpSp>
            <p:nvGrpSpPr>
              <p:cNvPr id="53" name="그룹 52"/>
              <p:cNvGrpSpPr/>
              <p:nvPr/>
            </p:nvGrpSpPr>
            <p:grpSpPr>
              <a:xfrm>
                <a:off x="1185989" y="586361"/>
                <a:ext cx="853530" cy="217869"/>
                <a:chOff x="1185989" y="586361"/>
                <a:chExt cx="853530" cy="217869"/>
              </a:xfrm>
            </p:grpSpPr>
            <p:sp>
              <p:nvSpPr>
                <p:cNvPr id="55" name="직사각형 54"/>
                <p:cNvSpPr/>
                <p:nvPr/>
              </p:nvSpPr>
              <p:spPr bwMode="auto">
                <a:xfrm>
                  <a:off x="1185989" y="586361"/>
                  <a:ext cx="312420" cy="144780"/>
                </a:xfrm>
                <a:prstGeom prst="rect">
                  <a:avLst/>
                </a:prstGeom>
                <a:noFill/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wrap="square" lIns="18288" tIns="0" rIns="0" bIns="0" rtlCol="0" anchor="t" upright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ko-KR" sz="1000" b="1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***</a:t>
                  </a:r>
                  <a:endParaRPr lang="ko-KR" altLang="en-US" sz="1000" b="1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직사각형 55"/>
                <p:cNvSpPr/>
                <p:nvPr/>
              </p:nvSpPr>
              <p:spPr bwMode="auto">
                <a:xfrm>
                  <a:off x="1727101" y="620414"/>
                  <a:ext cx="312418" cy="183816"/>
                </a:xfrm>
                <a:prstGeom prst="rect">
                  <a:avLst/>
                </a:prstGeom>
                <a:noFill/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wrap="square" lIns="18288" tIns="0" rIns="0" bIns="0" rtlCol="0" anchor="t" upright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ko-KR" sz="1000" b="1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***</a:t>
                  </a:r>
                  <a:endParaRPr lang="ko-KR" altLang="en-US" sz="1000" b="1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4" name="TextBox 199"/>
              <p:cNvSpPr txBox="1"/>
              <p:nvPr/>
            </p:nvSpPr>
            <p:spPr>
              <a:xfrm rot="16200000">
                <a:off x="-573867" y="503370"/>
                <a:ext cx="1333540" cy="2058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900">
                    <a:latin typeface="Arial" panose="020B0604020202020204" pitchFamily="34" charset="0"/>
                    <a:cs typeface="Arial" panose="020B0604020202020204" pitchFamily="34" charset="0"/>
                  </a:rPr>
                  <a:t>Relative cell count</a:t>
                </a:r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7" name="그룹 56"/>
          <p:cNvGrpSpPr/>
          <p:nvPr/>
        </p:nvGrpSpPr>
        <p:grpSpPr>
          <a:xfrm>
            <a:off x="3358137" y="3987398"/>
            <a:ext cx="2226122" cy="1687087"/>
            <a:chOff x="10273" y="0"/>
            <a:chExt cx="2226122" cy="1687087"/>
          </a:xfrm>
        </p:grpSpPr>
        <p:graphicFrame>
          <p:nvGraphicFramePr>
            <p:cNvPr id="58" name="차트 57"/>
            <p:cNvGraphicFramePr>
              <a:graphicFrameLocks/>
            </p:cNvGraphicFramePr>
            <p:nvPr/>
          </p:nvGraphicFramePr>
          <p:xfrm>
            <a:off x="112395" y="0"/>
            <a:ext cx="2124000" cy="162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pSp>
          <p:nvGrpSpPr>
            <p:cNvPr id="59" name="그룹 58"/>
            <p:cNvGrpSpPr/>
            <p:nvPr/>
          </p:nvGrpSpPr>
          <p:grpSpPr>
            <a:xfrm>
              <a:off x="10273" y="213815"/>
              <a:ext cx="1561897" cy="1473272"/>
              <a:chOff x="10273" y="229228"/>
              <a:chExt cx="1561897" cy="3683179"/>
            </a:xfrm>
          </p:grpSpPr>
          <p:sp>
            <p:nvSpPr>
              <p:cNvPr id="60" name="직사각형 59"/>
              <p:cNvSpPr/>
              <p:nvPr/>
            </p:nvSpPr>
            <p:spPr>
              <a:xfrm rot="16200000">
                <a:off x="-1282316" y="1521817"/>
                <a:ext cx="281600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Relative intensity</a:t>
                </a:r>
                <a:endParaRPr lang="ko-KR" altLang="en-US" sz="90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61" name="직사각형 60"/>
              <p:cNvSpPr/>
              <p:nvPr/>
            </p:nvSpPr>
            <p:spPr>
              <a:xfrm>
                <a:off x="1013998" y="3459525"/>
                <a:ext cx="558172" cy="452882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Days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2" name="TextBox 61"/>
          <p:cNvSpPr txBox="1"/>
          <p:nvPr/>
        </p:nvSpPr>
        <p:spPr>
          <a:xfrm>
            <a:off x="3275856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14016" y="1704104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c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279183" y="1700808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d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08390" y="3813599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e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273557" y="3810303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f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7" name="직사각형 66"/>
          <p:cNvSpPr/>
          <p:nvPr/>
        </p:nvSpPr>
        <p:spPr>
          <a:xfrm>
            <a:off x="813576" y="1196752"/>
            <a:ext cx="90601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1.00  0.55  0.38</a:t>
            </a:r>
            <a:endParaRPr lang="ko-KR" altLang="en-US" sz="8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8" name="직사각형 67"/>
          <p:cNvSpPr/>
          <p:nvPr/>
        </p:nvSpPr>
        <p:spPr>
          <a:xfrm>
            <a:off x="3828067" y="1196752"/>
            <a:ext cx="90601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1.00  0.09  0.26</a:t>
            </a:r>
            <a:endParaRPr lang="ko-KR" altLang="en-US" sz="8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57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1435" y="9355"/>
            <a:ext cx="2915940" cy="3755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itchFamily="34" charset="0"/>
                <a:ea typeface="Gulim" panose="020B0600000101010101" pitchFamily="50" charset="-127"/>
                <a:cs typeface="Arial" pitchFamily="34" charset="0"/>
              </a:rPr>
              <a:t>Fig. S3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10689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6164" y="806605"/>
            <a:ext cx="1365391" cy="198103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7821" y="806605"/>
            <a:ext cx="1365391" cy="198103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9478" y="806605"/>
            <a:ext cx="1366904" cy="1981036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2647" y="806605"/>
            <a:ext cx="1365391" cy="1981036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157" y="2844360"/>
            <a:ext cx="1350547" cy="1987132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9689" y="2844360"/>
            <a:ext cx="1350547" cy="1981036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221" y="2844360"/>
            <a:ext cx="1350547" cy="1981036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8754" y="2844360"/>
            <a:ext cx="1350658" cy="1987296"/>
          </a:xfrm>
          <a:prstGeom prst="rect">
            <a:avLst/>
          </a:prstGeom>
        </p:spPr>
      </p:pic>
      <p:sp>
        <p:nvSpPr>
          <p:cNvPr id="14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>
            <a:off x="35496" y="1598603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hContro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4">
            <a:extLst>
              <a:ext uri="{FF2B5EF4-FFF2-40B4-BE49-F238E27FC236}">
                <a16:creationId xmlns:a16="http://schemas.microsoft.com/office/drawing/2014/main" xmlns="" id="{689635D5-DB5E-4142-8DE3-48C999D6EB70}"/>
              </a:ext>
            </a:extLst>
          </p:cNvPr>
          <p:cNvSpPr txBox="1"/>
          <p:nvPr/>
        </p:nvSpPr>
        <p:spPr>
          <a:xfrm>
            <a:off x="35496" y="3649331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hGRPR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>
            <a:off x="1082118" y="562932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>
            <a:off x="2441644" y="557306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Wee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>
            <a:off x="3851920" y="562932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 Wee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>
            <a:off x="5229704" y="557306"/>
            <a:ext cx="762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 Wee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372200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1" name="차트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1674528"/>
              </p:ext>
            </p:extLst>
          </p:nvPr>
        </p:nvGraphicFramePr>
        <p:xfrm>
          <a:off x="6745912" y="784230"/>
          <a:ext cx="2229416" cy="2299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2" name="TextBox 3">
            <a:extLst>
              <a:ext uri="{FF2B5EF4-FFF2-40B4-BE49-F238E27FC236}">
                <a16:creationId xmlns:a16="http://schemas.microsoft.com/office/drawing/2014/main" xmlns="" id="{A1439E67-42C4-4324-A304-B59E0066289E}"/>
              </a:ext>
            </a:extLst>
          </p:cNvPr>
          <p:cNvSpPr txBox="1"/>
          <p:nvPr/>
        </p:nvSpPr>
        <p:spPr>
          <a:xfrm rot="16200000">
            <a:off x="5740709" y="1718732"/>
            <a:ext cx="1797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etastatic burde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7901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1" t="8809" r="39835"/>
          <a:stretch/>
        </p:blipFill>
        <p:spPr bwMode="auto">
          <a:xfrm rot="5400000" flipH="1" flipV="1">
            <a:off x="7786736" y="2287107"/>
            <a:ext cx="606828" cy="1172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7611791" y="1103432"/>
            <a:ext cx="960437" cy="1176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7" t="4203" r="6648" b="53452"/>
          <a:stretch/>
        </p:blipFill>
        <p:spPr bwMode="auto">
          <a:xfrm rot="16200000" flipH="1" flipV="1">
            <a:off x="2981905" y="1363988"/>
            <a:ext cx="1105763" cy="774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그룹 4"/>
          <p:cNvGrpSpPr/>
          <p:nvPr/>
        </p:nvGrpSpPr>
        <p:grpSpPr>
          <a:xfrm>
            <a:off x="3995936" y="2164214"/>
            <a:ext cx="375057" cy="184666"/>
            <a:chOff x="899592" y="2414766"/>
            <a:chExt cx="375057" cy="184666"/>
          </a:xfrm>
        </p:grpSpPr>
        <p:sp>
          <p:nvSpPr>
            <p:cNvPr id="6" name="TextBox 5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TextBox 7"/>
          <p:cNvSpPr txBox="1"/>
          <p:nvPr/>
        </p:nvSpPr>
        <p:spPr>
          <a:xfrm>
            <a:off x="3213716" y="1022911"/>
            <a:ext cx="636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Control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20389" y="1027675"/>
            <a:ext cx="684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GRPR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1856" y="1553202"/>
            <a:ext cx="432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Flag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96" t="3848" r="8727" b="42681"/>
          <a:stretch/>
        </p:blipFill>
        <p:spPr bwMode="auto">
          <a:xfrm rot="16200000" flipH="1">
            <a:off x="784275" y="1271131"/>
            <a:ext cx="973885" cy="8930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2" name="그룹 11"/>
          <p:cNvGrpSpPr/>
          <p:nvPr/>
        </p:nvGrpSpPr>
        <p:grpSpPr>
          <a:xfrm>
            <a:off x="1754723" y="2064735"/>
            <a:ext cx="425759" cy="184666"/>
            <a:chOff x="861492" y="2395716"/>
            <a:chExt cx="425759" cy="184666"/>
          </a:xfrm>
        </p:grpSpPr>
        <p:sp>
          <p:nvSpPr>
            <p:cNvPr id="13" name="TextBox 12"/>
            <p:cNvSpPr txBox="1"/>
            <p:nvPr/>
          </p:nvSpPr>
          <p:spPr>
            <a:xfrm>
              <a:off x="927251" y="239571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" name="직선 연결선 13"/>
            <p:cNvCxnSpPr/>
            <p:nvPr/>
          </p:nvCxnSpPr>
          <p:spPr>
            <a:xfrm>
              <a:off x="861492" y="248737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824710" y="962510"/>
            <a:ext cx="636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Control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31383" y="967274"/>
            <a:ext cx="684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GRPR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07002" y="1556504"/>
            <a:ext cx="432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Flag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1018044" y="1876455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/>
          <p:cNvSpPr/>
          <p:nvPr/>
        </p:nvSpPr>
        <p:spPr>
          <a:xfrm>
            <a:off x="72150" y="9355"/>
            <a:ext cx="84524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Gulim" panose="020B0600000101010101" pitchFamily="50" charset="-127"/>
                <a:cs typeface="Arial" panose="020B0604020202020204" pitchFamily="34" charset="0"/>
              </a:rPr>
              <a:t>Fig. S4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75137" y="568145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549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99068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2455317" y="568144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427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3" name="직사각형 22"/>
          <p:cNvSpPr/>
          <p:nvPr/>
        </p:nvSpPr>
        <p:spPr>
          <a:xfrm>
            <a:off x="3342700" y="1987391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027"/>
          <a:stretch/>
        </p:blipFill>
        <p:spPr bwMode="auto">
          <a:xfrm rot="16200000" flipH="1">
            <a:off x="5393616" y="1090057"/>
            <a:ext cx="935037" cy="11661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2" r="26693" b="50751"/>
          <a:stretch/>
        </p:blipFill>
        <p:spPr bwMode="auto">
          <a:xfrm rot="16200000" flipH="1">
            <a:off x="5616115" y="2263125"/>
            <a:ext cx="517060" cy="1139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4674362" y="389138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7" name="직사각형 26"/>
          <p:cNvSpPr/>
          <p:nvPr/>
        </p:nvSpPr>
        <p:spPr>
          <a:xfrm>
            <a:off x="4687565" y="568145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549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28" name="그룹 27"/>
          <p:cNvGrpSpPr/>
          <p:nvPr/>
        </p:nvGrpSpPr>
        <p:grpSpPr>
          <a:xfrm>
            <a:off x="6468715" y="2939147"/>
            <a:ext cx="425759" cy="184666"/>
            <a:chOff x="861492" y="2395716"/>
            <a:chExt cx="425759" cy="184666"/>
          </a:xfrm>
        </p:grpSpPr>
        <p:sp>
          <p:nvSpPr>
            <p:cNvPr id="29" name="TextBox 28"/>
            <p:cNvSpPr txBox="1"/>
            <p:nvPr/>
          </p:nvSpPr>
          <p:spPr>
            <a:xfrm>
              <a:off x="927251" y="239571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0" name="직선 연결선 29"/>
            <p:cNvCxnSpPr/>
            <p:nvPr/>
          </p:nvCxnSpPr>
          <p:spPr>
            <a:xfrm>
              <a:off x="861492" y="248737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그룹 30"/>
          <p:cNvGrpSpPr/>
          <p:nvPr/>
        </p:nvGrpSpPr>
        <p:grpSpPr>
          <a:xfrm>
            <a:off x="4707051" y="810397"/>
            <a:ext cx="1828366" cy="2175978"/>
            <a:chOff x="-5707" y="745020"/>
            <a:chExt cx="1395338" cy="2312595"/>
          </a:xfrm>
        </p:grpSpPr>
        <p:grpSp>
          <p:nvGrpSpPr>
            <p:cNvPr id="32" name="그룹 31"/>
            <p:cNvGrpSpPr/>
            <p:nvPr/>
          </p:nvGrpSpPr>
          <p:grpSpPr>
            <a:xfrm>
              <a:off x="-5707" y="745020"/>
              <a:ext cx="1395338" cy="2312595"/>
              <a:chOff x="3640" y="1085107"/>
              <a:chExt cx="1120170" cy="2312595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302388" y="1231481"/>
                <a:ext cx="642015" cy="228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 err="1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shControl</a:t>
                </a:r>
                <a:endPara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37838" y="1085107"/>
                <a:ext cx="585972" cy="228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 err="1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shGRPR</a:t>
                </a:r>
                <a:endPara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640" y="1955509"/>
                <a:ext cx="389530" cy="2616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GRPR</a:t>
                </a:r>
                <a:endParaRPr lang="ko-KR" altLang="en-US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8" name="직사각형 37"/>
              <p:cNvSpPr/>
              <p:nvPr/>
            </p:nvSpPr>
            <p:spPr>
              <a:xfrm>
                <a:off x="29532" y="3136022"/>
                <a:ext cx="349824" cy="26168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β-</a:t>
                </a:r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3" name="직선 연결선 32"/>
            <p:cNvCxnSpPr/>
            <p:nvPr/>
          </p:nvCxnSpPr>
          <p:spPr>
            <a:xfrm>
              <a:off x="839281" y="983964"/>
              <a:ext cx="41210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773230" y="993663"/>
              <a:ext cx="533809" cy="22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 1          2</a:t>
              </a:r>
            </a:p>
          </p:txBody>
        </p:sp>
      </p:grpSp>
      <p:grpSp>
        <p:nvGrpSpPr>
          <p:cNvPr id="39" name="그룹 38"/>
          <p:cNvGrpSpPr/>
          <p:nvPr/>
        </p:nvGrpSpPr>
        <p:grpSpPr>
          <a:xfrm>
            <a:off x="6444208" y="1601905"/>
            <a:ext cx="425759" cy="184666"/>
            <a:chOff x="861492" y="2395716"/>
            <a:chExt cx="425759" cy="184666"/>
          </a:xfrm>
        </p:grpSpPr>
        <p:sp>
          <p:nvSpPr>
            <p:cNvPr id="40" name="TextBox 39"/>
            <p:cNvSpPr txBox="1"/>
            <p:nvPr/>
          </p:nvSpPr>
          <p:spPr>
            <a:xfrm>
              <a:off x="927251" y="239571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50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" name="직선 연결선 40"/>
            <p:cNvCxnSpPr/>
            <p:nvPr/>
          </p:nvCxnSpPr>
          <p:spPr>
            <a:xfrm>
              <a:off x="861492" y="248737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직사각형 41"/>
          <p:cNvSpPr/>
          <p:nvPr/>
        </p:nvSpPr>
        <p:spPr>
          <a:xfrm>
            <a:off x="5450034" y="1629380"/>
            <a:ext cx="904238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직사각형 42"/>
          <p:cNvSpPr/>
          <p:nvPr/>
        </p:nvSpPr>
        <p:spPr>
          <a:xfrm>
            <a:off x="5450034" y="2768797"/>
            <a:ext cx="904238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/>
          <p:cNvSpPr/>
          <p:nvPr/>
        </p:nvSpPr>
        <p:spPr>
          <a:xfrm>
            <a:off x="6919813" y="574473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427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45" name="그룹 44"/>
          <p:cNvGrpSpPr/>
          <p:nvPr/>
        </p:nvGrpSpPr>
        <p:grpSpPr>
          <a:xfrm>
            <a:off x="8676395" y="2877281"/>
            <a:ext cx="425759" cy="184666"/>
            <a:chOff x="861492" y="2395716"/>
            <a:chExt cx="425759" cy="184666"/>
          </a:xfrm>
        </p:grpSpPr>
        <p:sp>
          <p:nvSpPr>
            <p:cNvPr id="46" name="TextBox 45"/>
            <p:cNvSpPr txBox="1"/>
            <p:nvPr/>
          </p:nvSpPr>
          <p:spPr>
            <a:xfrm>
              <a:off x="927251" y="239571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7" name="직선 연결선 46"/>
            <p:cNvCxnSpPr/>
            <p:nvPr/>
          </p:nvCxnSpPr>
          <p:spPr>
            <a:xfrm>
              <a:off x="861492" y="248737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그룹 47"/>
          <p:cNvGrpSpPr/>
          <p:nvPr/>
        </p:nvGrpSpPr>
        <p:grpSpPr>
          <a:xfrm>
            <a:off x="6914731" y="814366"/>
            <a:ext cx="1828366" cy="2175978"/>
            <a:chOff x="-5707" y="745020"/>
            <a:chExt cx="1395338" cy="2312595"/>
          </a:xfrm>
        </p:grpSpPr>
        <p:grpSp>
          <p:nvGrpSpPr>
            <p:cNvPr id="49" name="그룹 48"/>
            <p:cNvGrpSpPr/>
            <p:nvPr/>
          </p:nvGrpSpPr>
          <p:grpSpPr>
            <a:xfrm>
              <a:off x="-5707" y="745020"/>
              <a:ext cx="1395338" cy="2312595"/>
              <a:chOff x="3640" y="1085107"/>
              <a:chExt cx="1120170" cy="2312595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302388" y="1231481"/>
                <a:ext cx="642015" cy="228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 err="1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shControl</a:t>
                </a:r>
                <a:endPara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537838" y="1085107"/>
                <a:ext cx="585972" cy="228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 err="1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shGRPR</a:t>
                </a:r>
                <a:endPara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640" y="1955509"/>
                <a:ext cx="389530" cy="2616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GRPR</a:t>
                </a:r>
                <a:endParaRPr lang="ko-KR" altLang="en-US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55" name="직사각형 54"/>
              <p:cNvSpPr/>
              <p:nvPr/>
            </p:nvSpPr>
            <p:spPr>
              <a:xfrm>
                <a:off x="29532" y="3136022"/>
                <a:ext cx="349824" cy="26168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β-</a:t>
                </a:r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0" name="직선 연결선 49"/>
            <p:cNvCxnSpPr/>
            <p:nvPr/>
          </p:nvCxnSpPr>
          <p:spPr>
            <a:xfrm>
              <a:off x="839281" y="983964"/>
              <a:ext cx="41210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773230" y="993663"/>
              <a:ext cx="533809" cy="22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 1          2</a:t>
              </a:r>
            </a:p>
          </p:txBody>
        </p:sp>
      </p:grpSp>
      <p:grpSp>
        <p:nvGrpSpPr>
          <p:cNvPr id="56" name="그룹 55"/>
          <p:cNvGrpSpPr/>
          <p:nvPr/>
        </p:nvGrpSpPr>
        <p:grpSpPr>
          <a:xfrm>
            <a:off x="8651888" y="1591244"/>
            <a:ext cx="425759" cy="184666"/>
            <a:chOff x="861492" y="2395716"/>
            <a:chExt cx="425759" cy="184666"/>
          </a:xfrm>
        </p:grpSpPr>
        <p:sp>
          <p:nvSpPr>
            <p:cNvPr id="57" name="TextBox 56"/>
            <p:cNvSpPr txBox="1"/>
            <p:nvPr/>
          </p:nvSpPr>
          <p:spPr>
            <a:xfrm>
              <a:off x="927251" y="239571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50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8" name="직선 연결선 57"/>
            <p:cNvCxnSpPr/>
            <p:nvPr/>
          </p:nvCxnSpPr>
          <p:spPr>
            <a:xfrm>
              <a:off x="861492" y="248737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직사각형 58"/>
          <p:cNvSpPr/>
          <p:nvPr/>
        </p:nvSpPr>
        <p:spPr>
          <a:xfrm>
            <a:off x="7657714" y="1647979"/>
            <a:ext cx="904238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직사각형 59"/>
          <p:cNvSpPr/>
          <p:nvPr/>
        </p:nvSpPr>
        <p:spPr>
          <a:xfrm>
            <a:off x="7657714" y="2772766"/>
            <a:ext cx="904238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1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4163" y="2328737"/>
            <a:ext cx="864000" cy="7592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3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6"/>
          <a:stretch/>
        </p:blipFill>
        <p:spPr bwMode="auto">
          <a:xfrm>
            <a:off x="3147598" y="2348881"/>
            <a:ext cx="774375" cy="7848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3" name="그룹 62"/>
          <p:cNvGrpSpPr/>
          <p:nvPr/>
        </p:nvGrpSpPr>
        <p:grpSpPr>
          <a:xfrm>
            <a:off x="3995936" y="2980117"/>
            <a:ext cx="375057" cy="184666"/>
            <a:chOff x="899592" y="2414766"/>
            <a:chExt cx="375057" cy="184666"/>
          </a:xfrm>
        </p:grpSpPr>
        <p:sp>
          <p:nvSpPr>
            <p:cNvPr id="64" name="TextBox 63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5" name="직선 연결선 64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그룹 65"/>
          <p:cNvGrpSpPr/>
          <p:nvPr/>
        </p:nvGrpSpPr>
        <p:grpSpPr>
          <a:xfrm>
            <a:off x="1763688" y="2909631"/>
            <a:ext cx="375057" cy="184666"/>
            <a:chOff x="816460" y="2414766"/>
            <a:chExt cx="375057" cy="184666"/>
          </a:xfrm>
        </p:grpSpPr>
        <p:sp>
          <p:nvSpPr>
            <p:cNvPr id="67" name="TextBox 66"/>
            <p:cNvSpPr txBox="1"/>
            <p:nvPr/>
          </p:nvSpPr>
          <p:spPr>
            <a:xfrm>
              <a:off x="831517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8" name="직선 연결선 67"/>
            <p:cNvCxnSpPr/>
            <p:nvPr/>
          </p:nvCxnSpPr>
          <p:spPr>
            <a:xfrm>
              <a:off x="816460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직사각형 68"/>
          <p:cNvSpPr/>
          <p:nvPr/>
        </p:nvSpPr>
        <p:spPr>
          <a:xfrm>
            <a:off x="993528" y="2739281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직사각형 69"/>
          <p:cNvSpPr/>
          <p:nvPr/>
        </p:nvSpPr>
        <p:spPr>
          <a:xfrm>
            <a:off x="3357193" y="2785957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TextBox 70"/>
          <p:cNvSpPr txBox="1"/>
          <p:nvPr/>
        </p:nvSpPr>
        <p:spPr>
          <a:xfrm>
            <a:off x="144884" y="2708920"/>
            <a:ext cx="682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521148" y="2709500"/>
            <a:ext cx="682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572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72150" y="9355"/>
            <a:ext cx="84524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Gulim" panose="020B0600000101010101" pitchFamily="50" charset="-127"/>
                <a:cs typeface="Arial" panose="020B0604020202020204" pitchFamily="34" charset="0"/>
              </a:rPr>
              <a:t>Fig. S5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922366" y="709618"/>
            <a:ext cx="116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Con  GRPR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291"/>
          <a:stretch/>
        </p:blipFill>
        <p:spPr bwMode="auto">
          <a:xfrm rot="16200000" flipV="1">
            <a:off x="5249319" y="198283"/>
            <a:ext cx="707560" cy="2173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983293" y="1106526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FNDC4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5874" r="19326" b="11668"/>
          <a:stretch/>
        </p:blipFill>
        <p:spPr bwMode="auto">
          <a:xfrm rot="16200000">
            <a:off x="5281383" y="919601"/>
            <a:ext cx="555813" cy="21035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004777" y="1817511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6622771" y="2034828"/>
            <a:ext cx="375057" cy="184666"/>
            <a:chOff x="899592" y="2414766"/>
            <a:chExt cx="375057" cy="184666"/>
          </a:xfrm>
        </p:grpSpPr>
        <p:sp>
          <p:nvSpPr>
            <p:cNvPr id="9" name="TextBox 8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" name="직선 연결선 9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직사각형 10"/>
          <p:cNvSpPr/>
          <p:nvPr/>
        </p:nvSpPr>
        <p:spPr>
          <a:xfrm>
            <a:off x="5984224" y="1931462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6006038" y="1153921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3" name="그룹 12"/>
          <p:cNvGrpSpPr/>
          <p:nvPr/>
        </p:nvGrpSpPr>
        <p:grpSpPr>
          <a:xfrm>
            <a:off x="6700383" y="1037655"/>
            <a:ext cx="375057" cy="184666"/>
            <a:chOff x="899592" y="2414766"/>
            <a:chExt cx="375057" cy="184666"/>
          </a:xfrm>
        </p:grpSpPr>
        <p:sp>
          <p:nvSpPr>
            <p:cNvPr id="14" name="TextBox 13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20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" name="직선 연결선 14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688803" y="90934"/>
            <a:ext cx="661987" cy="244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" t="443" r="8869" b="2921"/>
          <a:stretch/>
        </p:blipFill>
        <p:spPr bwMode="auto">
          <a:xfrm rot="5400000" flipH="1" flipV="1">
            <a:off x="1643219" y="1035603"/>
            <a:ext cx="654920" cy="2259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8" name="그룹 17"/>
          <p:cNvGrpSpPr/>
          <p:nvPr/>
        </p:nvGrpSpPr>
        <p:grpSpPr>
          <a:xfrm>
            <a:off x="3203689" y="2126114"/>
            <a:ext cx="375057" cy="184666"/>
            <a:chOff x="899592" y="2414766"/>
            <a:chExt cx="375057" cy="184666"/>
          </a:xfrm>
        </p:grpSpPr>
        <p:sp>
          <p:nvSpPr>
            <p:cNvPr id="19" name="TextBox 18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직선 연결선 19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그룹 20"/>
          <p:cNvGrpSpPr/>
          <p:nvPr/>
        </p:nvGrpSpPr>
        <p:grpSpPr>
          <a:xfrm>
            <a:off x="3260839" y="1167041"/>
            <a:ext cx="375057" cy="184666"/>
            <a:chOff x="899592" y="2414766"/>
            <a:chExt cx="375057" cy="184666"/>
          </a:xfrm>
        </p:grpSpPr>
        <p:sp>
          <p:nvSpPr>
            <p:cNvPr id="22" name="TextBox 21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15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3" name="직선 연결선 22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xtBox 23"/>
          <p:cNvSpPr txBox="1"/>
          <p:nvPr/>
        </p:nvSpPr>
        <p:spPr>
          <a:xfrm>
            <a:off x="2327299" y="756217"/>
            <a:ext cx="1169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Con  GRPR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직사각형 24"/>
          <p:cNvSpPr/>
          <p:nvPr/>
        </p:nvSpPr>
        <p:spPr>
          <a:xfrm>
            <a:off x="2389157" y="2014862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/>
          <p:cNvSpPr/>
          <p:nvPr/>
        </p:nvSpPr>
        <p:spPr>
          <a:xfrm>
            <a:off x="2410971" y="1237321"/>
            <a:ext cx="555377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99068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7504" y="1264580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CRABP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28988" y="1975565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793569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572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72150" y="9355"/>
            <a:ext cx="84524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Gulim" panose="020B0600000101010101" pitchFamily="50" charset="-127"/>
                <a:cs typeface="Arial" panose="020B0604020202020204" pitchFamily="34" charset="0"/>
              </a:rPr>
              <a:t>Fig. S6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6044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211960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5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" t="637" r="3245" b="28632"/>
          <a:stretch/>
        </p:blipFill>
        <p:spPr bwMode="auto">
          <a:xfrm>
            <a:off x="693478" y="3153656"/>
            <a:ext cx="2521683" cy="897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95" t="520" r="3793" b="875"/>
          <a:stretch/>
        </p:blipFill>
        <p:spPr bwMode="auto">
          <a:xfrm rot="5400000">
            <a:off x="1636106" y="300954"/>
            <a:ext cx="683850" cy="25280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0" t="467" r="21427" b="3111"/>
          <a:stretch/>
        </p:blipFill>
        <p:spPr bwMode="auto">
          <a:xfrm rot="5400000" flipH="1">
            <a:off x="1443676" y="1357479"/>
            <a:ext cx="1041815" cy="25011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18893" y="1046503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0    5   15   30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140559" y="1046503"/>
            <a:ext cx="7906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GRP (min)</a:t>
            </a:r>
          </a:p>
        </p:txBody>
      </p:sp>
      <p:cxnSp>
        <p:nvCxnSpPr>
          <p:cNvPr id="10" name="직선 연결선 9"/>
          <p:cNvCxnSpPr/>
          <p:nvPr/>
        </p:nvCxnSpPr>
        <p:spPr>
          <a:xfrm>
            <a:off x="970117" y="1039195"/>
            <a:ext cx="93309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105093" y="79100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35714" y="1046503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0    5   15   30 </a:t>
            </a:r>
          </a:p>
        </p:txBody>
      </p:sp>
      <p:cxnSp>
        <p:nvCxnSpPr>
          <p:cNvPr id="13" name="직선 연결선 12"/>
          <p:cNvCxnSpPr/>
          <p:nvPr/>
        </p:nvCxnSpPr>
        <p:spPr>
          <a:xfrm>
            <a:off x="1978229" y="1039195"/>
            <a:ext cx="93309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152372" y="791004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GRPR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134469" y="1679309"/>
            <a:ext cx="369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 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55308" y="1347314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75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9512" y="1512007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p-AKT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40296" y="2582003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40296" y="2219909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75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28757" y="2530019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t-AKT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75137" y="580833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549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088124" y="1046503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0    5   15   30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207380" y="1046503"/>
            <a:ext cx="7906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GRP (min)</a:t>
            </a:r>
          </a:p>
        </p:txBody>
      </p:sp>
      <p:cxnSp>
        <p:nvCxnSpPr>
          <p:cNvPr id="24" name="직선 연결선 23"/>
          <p:cNvCxnSpPr/>
          <p:nvPr/>
        </p:nvCxnSpPr>
        <p:spPr>
          <a:xfrm>
            <a:off x="5139348" y="1039195"/>
            <a:ext cx="93309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5274324" y="79100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104945" y="1046503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0    5   15   30 </a:t>
            </a:r>
          </a:p>
        </p:txBody>
      </p:sp>
      <p:cxnSp>
        <p:nvCxnSpPr>
          <p:cNvPr id="27" name="직선 연결선 26"/>
          <p:cNvCxnSpPr/>
          <p:nvPr/>
        </p:nvCxnSpPr>
        <p:spPr>
          <a:xfrm>
            <a:off x="6147460" y="1039195"/>
            <a:ext cx="93309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6321603" y="791004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itchFamily="34" charset="0"/>
                <a:cs typeface="Arial" pitchFamily="34" charset="0"/>
              </a:rPr>
              <a:t>GRPR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201290" y="1701254"/>
            <a:ext cx="369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 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222129" y="1347314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75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348743" y="1512007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p-AKT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207117" y="2582003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207117" y="2219909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75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397988" y="2530019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t-AKT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직사각형 34"/>
          <p:cNvSpPr/>
          <p:nvPr/>
        </p:nvSpPr>
        <p:spPr>
          <a:xfrm>
            <a:off x="4244368" y="580833"/>
            <a:ext cx="18286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427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36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1" r="9318"/>
          <a:stretch/>
        </p:blipFill>
        <p:spPr bwMode="auto">
          <a:xfrm rot="16200000">
            <a:off x="5648428" y="450692"/>
            <a:ext cx="810479" cy="249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6" r="13015"/>
          <a:stretch/>
        </p:blipFill>
        <p:spPr bwMode="auto">
          <a:xfrm rot="16200000" flipH="1">
            <a:off x="5604898" y="1349804"/>
            <a:ext cx="878246" cy="2475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직사각형 37"/>
          <p:cNvSpPr/>
          <p:nvPr/>
        </p:nvSpPr>
        <p:spPr>
          <a:xfrm>
            <a:off x="848271" y="1425563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직사각형 38"/>
          <p:cNvSpPr/>
          <p:nvPr/>
        </p:nvSpPr>
        <p:spPr>
          <a:xfrm>
            <a:off x="848271" y="2325204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직사각형 39"/>
          <p:cNvSpPr/>
          <p:nvPr/>
        </p:nvSpPr>
        <p:spPr>
          <a:xfrm>
            <a:off x="4935931" y="1431828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직사각형 40"/>
          <p:cNvSpPr/>
          <p:nvPr/>
        </p:nvSpPr>
        <p:spPr>
          <a:xfrm>
            <a:off x="4945168" y="2317925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TextBox 41"/>
          <p:cNvSpPr txBox="1"/>
          <p:nvPr/>
        </p:nvSpPr>
        <p:spPr>
          <a:xfrm>
            <a:off x="218430" y="3441688"/>
            <a:ext cx="933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153705" y="3645940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37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157718" y="3343802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5" name="Picture 5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2" t="2167" r="-170" b="39832"/>
          <a:stretch/>
        </p:blipFill>
        <p:spPr bwMode="auto">
          <a:xfrm>
            <a:off x="4874710" y="3235843"/>
            <a:ext cx="2424968" cy="6896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4397862" y="3452603"/>
            <a:ext cx="933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7204227" y="366319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37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208240" y="3343802"/>
            <a:ext cx="3449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dirty="0">
                <a:latin typeface="Arial" pitchFamily="34" charset="0"/>
                <a:cs typeface="Arial" pitchFamily="34" charset="0"/>
              </a:rPr>
              <a:t>━50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847836" y="3426698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직사각형 49"/>
          <p:cNvSpPr/>
          <p:nvPr/>
        </p:nvSpPr>
        <p:spPr>
          <a:xfrm>
            <a:off x="4944733" y="3419419"/>
            <a:ext cx="2286198" cy="43841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7572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 flipH="1" flipV="1">
            <a:off x="5099868" y="858357"/>
            <a:ext cx="704850" cy="1109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026505" y="810377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err="1">
                <a:latin typeface="Arial" pitchFamily="34" charset="0"/>
                <a:cs typeface="Arial" pitchFamily="34" charset="0"/>
              </a:rPr>
              <a:t>sico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377579" y="702221"/>
            <a:ext cx="945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siFNDC4</a:t>
            </a:r>
          </a:p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   1     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62114" y="1223919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FNDC4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083598" y="2126230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96" b="-1"/>
          <a:stretch/>
        </p:blipFill>
        <p:spPr bwMode="auto">
          <a:xfrm rot="5400000" flipH="1" flipV="1">
            <a:off x="5056501" y="1754075"/>
            <a:ext cx="695325" cy="12125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" name="그룹 7"/>
          <p:cNvGrpSpPr/>
          <p:nvPr/>
        </p:nvGrpSpPr>
        <p:grpSpPr>
          <a:xfrm>
            <a:off x="6020114" y="2524254"/>
            <a:ext cx="375057" cy="184666"/>
            <a:chOff x="899592" y="2414766"/>
            <a:chExt cx="375057" cy="184666"/>
          </a:xfrm>
        </p:grpSpPr>
        <p:sp>
          <p:nvSpPr>
            <p:cNvPr id="9" name="TextBox 8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" name="직선 연결선 9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그룹 10"/>
          <p:cNvGrpSpPr/>
          <p:nvPr/>
        </p:nvGrpSpPr>
        <p:grpSpPr>
          <a:xfrm>
            <a:off x="6069151" y="1219999"/>
            <a:ext cx="375057" cy="184666"/>
            <a:chOff x="899592" y="2414766"/>
            <a:chExt cx="375057" cy="184666"/>
          </a:xfrm>
        </p:grpSpPr>
        <p:sp>
          <p:nvSpPr>
            <p:cNvPr id="12" name="TextBox 11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20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직선 연결선 12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217" b="31265"/>
          <a:stretch/>
        </p:blipFill>
        <p:spPr bwMode="auto">
          <a:xfrm rot="5400000" flipH="1" flipV="1">
            <a:off x="1678699" y="585459"/>
            <a:ext cx="644640" cy="1636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" t="443" r="8869" b="32819"/>
          <a:stretch/>
        </p:blipFill>
        <p:spPr bwMode="auto">
          <a:xfrm rot="5400000" flipH="1" flipV="1">
            <a:off x="1635460" y="1529172"/>
            <a:ext cx="654920" cy="15605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직사각형 15"/>
          <p:cNvSpPr/>
          <p:nvPr/>
        </p:nvSpPr>
        <p:spPr>
          <a:xfrm>
            <a:off x="1625005" y="1306983"/>
            <a:ext cx="930771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1625005" y="2178446"/>
            <a:ext cx="930771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5089343" y="1208130"/>
            <a:ext cx="930771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/>
          <p:cNvSpPr/>
          <p:nvPr/>
        </p:nvSpPr>
        <p:spPr>
          <a:xfrm>
            <a:off x="5089343" y="2384427"/>
            <a:ext cx="930771" cy="26201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TextBox 19"/>
          <p:cNvSpPr txBox="1"/>
          <p:nvPr/>
        </p:nvSpPr>
        <p:spPr>
          <a:xfrm>
            <a:off x="1557190" y="813535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err="1">
                <a:latin typeface="Arial" pitchFamily="34" charset="0"/>
                <a:cs typeface="Arial" pitchFamily="34" charset="0"/>
              </a:rPr>
              <a:t>sico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08264" y="705379"/>
            <a:ext cx="945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siCRABP2</a:t>
            </a:r>
          </a:p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   1     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그룹 21"/>
          <p:cNvGrpSpPr/>
          <p:nvPr/>
        </p:nvGrpSpPr>
        <p:grpSpPr>
          <a:xfrm>
            <a:off x="2762275" y="2267473"/>
            <a:ext cx="375057" cy="184666"/>
            <a:chOff x="899592" y="2414766"/>
            <a:chExt cx="375057" cy="184666"/>
          </a:xfrm>
        </p:grpSpPr>
        <p:sp>
          <p:nvSpPr>
            <p:cNvPr id="23" name="TextBox 22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37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" name="직선 연결선 23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24"/>
          <p:cNvGrpSpPr/>
          <p:nvPr/>
        </p:nvGrpSpPr>
        <p:grpSpPr>
          <a:xfrm>
            <a:off x="2816645" y="1166228"/>
            <a:ext cx="375057" cy="184666"/>
            <a:chOff x="899592" y="2414766"/>
            <a:chExt cx="375057" cy="184666"/>
          </a:xfrm>
        </p:grpSpPr>
        <p:sp>
          <p:nvSpPr>
            <p:cNvPr id="26" name="TextBox 25"/>
            <p:cNvSpPr txBox="1"/>
            <p:nvPr/>
          </p:nvSpPr>
          <p:spPr>
            <a:xfrm>
              <a:off x="914649" y="2414766"/>
              <a:ext cx="36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itchFamily="34" charset="0"/>
                  <a:cs typeface="Arial" pitchFamily="34" charset="0"/>
                </a:rPr>
                <a:t>20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직선 연결선 26"/>
            <p:cNvCxnSpPr/>
            <p:nvPr/>
          </p:nvCxnSpPr>
          <p:spPr>
            <a:xfrm>
              <a:off x="899592" y="2506426"/>
              <a:ext cx="72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Box 27"/>
          <p:cNvSpPr txBox="1"/>
          <p:nvPr/>
        </p:nvSpPr>
        <p:spPr>
          <a:xfrm>
            <a:off x="544818" y="1176952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CRABP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66302" y="2079263"/>
            <a:ext cx="1269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9068" y="387412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a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93569" y="38411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b) </a:t>
            </a:r>
            <a:endParaRPr lang="ko-KR" altLang="en-US" sz="1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2" name="직사각형 31"/>
          <p:cNvSpPr/>
          <p:nvPr/>
        </p:nvSpPr>
        <p:spPr>
          <a:xfrm>
            <a:off x="72150" y="9355"/>
            <a:ext cx="84524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ea typeface="Gulim" panose="020B0600000101010101" pitchFamily="50" charset="-127"/>
                <a:cs typeface="Arial" panose="020B0604020202020204" pitchFamily="34" charset="0"/>
              </a:rPr>
              <a:t>Fig. S7</a:t>
            </a:r>
            <a:endParaRPr lang="en-US" altLang="ko-KR" sz="1400" b="1" dirty="0">
              <a:latin typeface="Arial" panose="020B0604020202020204" pitchFamily="34" charset="0"/>
              <a:ea typeface="Gulim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57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72</Words>
  <Application>Microsoft Office PowerPoint</Application>
  <PresentationFormat>화면 슬라이드 쇼(4:3)</PresentationFormat>
  <Paragraphs>146</Paragraphs>
  <Slides>7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8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-YJK</dc:creator>
  <cp:lastModifiedBy>NCC-YJK</cp:lastModifiedBy>
  <cp:revision>7</cp:revision>
  <dcterms:created xsi:type="dcterms:W3CDTF">2024-10-28T01:15:44Z</dcterms:created>
  <dcterms:modified xsi:type="dcterms:W3CDTF">2024-11-13T05:24:34Z</dcterms:modified>
</cp:coreProperties>
</file>